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8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D580E40-6A61-0348-4F0B-98029EFE3E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83CBB7C-14D1-48C1-9565-B4109A0B0D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pt-PT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8F818B5-AA94-9E78-B0B1-09BDD3AE8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DB1FC446-79F4-6710-1B71-E768D9638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3EE1420-0B05-D50B-28C7-8F4AD6135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030853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A320BB-4109-E56E-2291-485DE64841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96355A97-B67C-8CC9-8BEC-3963723659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pt-PT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F8F1D38-5E30-6692-D026-75B8E46D6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8BF94FDF-8002-7A4B-A938-F52767C96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82DA732-A9EC-FB56-51EC-83D3FCF5F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045764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F506FF07-9D9F-36A5-A3B0-A36D4375303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BE810945-9CF2-4405-3F77-6895ADD7CF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pt-PT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03AEFC8-23F4-EFC8-0845-D92D1D9A9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8A7DB16-F1E8-9D0A-19B4-BD086DE8C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F222F51-D038-2BCD-3B47-648FFA75C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502288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537312F-44CA-F03D-C3F7-F6894D11D6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C0B39B44-A3BD-4A23-3BD4-E078968021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pt-PT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070F2AF-34B0-DD40-AEFE-A1B4E3D16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9F7B88B-076A-BB22-C2C3-BDF2226E7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D21E1EB-43FD-6C95-A39F-88ECB338D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62942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84EA70-6A98-5706-0421-4D3ECDBBC5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B736BE7E-A02E-5E4C-49C6-352904A26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25E8BA4-33C7-3FD8-8750-534D2D0A6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56407FA-462C-4359-3959-C7801E45E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CCDDD26-9C30-E50B-ED1C-CA7ADBDF6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568006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CE78845-FED5-2C25-37EC-E6B97B8601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2453611-9B09-C478-994D-B952CFD3C9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pt-PT"/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0249363C-0BF7-4678-9ACA-630EAD8DBF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pt-PT"/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319E436-8B52-EA3C-83E2-B2C127535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4EDDD56-4EE0-8953-F340-E5C6641A1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7AD8D8F-7D99-4167-CA0A-4CF0A711B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219073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063E8D-376E-D96D-C52D-698E62AC1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F52D378-8AA8-5101-0B49-D839701DAE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2648DB67-1E0B-19B3-EAB5-A093B3344A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pt-PT"/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0A2356B1-D6B4-12DA-4E0D-95720911AA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3DC36A86-7FEA-4DF2-A7EC-09BC9E3596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pt-PT"/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FD316D2B-B67E-A6D8-BE75-32A846773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98E58B3A-719E-5654-98B1-75A56DA5D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F419F63C-5A1C-E045-484B-3F2137CE8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797020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E731B9D-C31D-B190-E46F-B4CDF5960B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C9879A17-4F4D-3E13-05D9-B66135C15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0136365C-3964-C216-BEEF-F2BAC4ADF8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7DD293FB-CD84-547E-0833-6CEF9260C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838486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C951115D-3409-83E4-C438-9964E60B8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95CFE359-4CBC-8E37-D786-FA570DB14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D0E7658B-8E0B-2265-0A18-4A9DC6FDE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5552172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7D734AB-685B-E0DB-49E7-2C03BEC612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E6360138-956E-E19F-C753-0E4F243E89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pt-PT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18837E96-0153-BFDE-A56C-B5F0B0831F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0DD8118C-0E68-758A-14EB-167220E7F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9B7E382-72F7-3144-526E-42FF5B4A9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CA0028EB-711E-80E8-75CD-67C40E4758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6207608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187D1CC-CE42-7A69-184D-6AEE3A340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FFC3AF77-00F1-DE1A-3081-C66DF5D1AF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4018F3DC-5BA3-EDE1-1121-481730284F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98443F5F-9CB9-B0F8-8260-5924C07E0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2E505D84-7F64-3DCE-FC10-48E69028C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DAFC4AED-3DC9-F325-6B14-518C551F84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29525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5575AB27-1181-39DF-3D93-033B5E2206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pt-PT"/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A7AE9F8A-D7B5-AE9B-3FE0-9DC70BD866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pt-PT"/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943485A-F056-2158-271F-D11915BD97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3CD1C-2F85-4A80-8919-9A76E2F81CA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87C915E-C862-22B2-F4EB-A0E1CF1BE1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F6C0C5F-9AC0-F882-24CC-6C27E1F032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BBD1B-F160-46FE-A5ED-B92C85661DEF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86205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D01C1842-5E11-1CBA-A791-98DFD4313C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3127174"/>
              </p:ext>
            </p:extLst>
          </p:nvPr>
        </p:nvGraphicFramePr>
        <p:xfrm>
          <a:off x="3341370" y="1154430"/>
          <a:ext cx="2606675" cy="3381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2607022" imgH="3381846" progId="Prism8.Document">
                  <p:embed/>
                </p:oleObj>
              </mc:Choice>
              <mc:Fallback>
                <p:oleObj name="Prism 8" r:id="rId3" imgW="2607022" imgH="338184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41370" y="1154430"/>
                        <a:ext cx="2606675" cy="3381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D1078B8D-0B34-84BA-5A9C-B2C562909C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0663912"/>
              </p:ext>
            </p:extLst>
          </p:nvPr>
        </p:nvGraphicFramePr>
        <p:xfrm>
          <a:off x="5809933" y="1154430"/>
          <a:ext cx="2355850" cy="3384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5" imgW="2355648" imgH="3384728" progId="Prism8.Document">
                  <p:embed/>
                </p:oleObj>
              </mc:Choice>
              <mc:Fallback>
                <p:oleObj name="Prism 8" r:id="rId5" imgW="2355648" imgH="338472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09933" y="1154430"/>
                        <a:ext cx="2355850" cy="3384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ixaDeTexto 6">
            <a:extLst>
              <a:ext uri="{FF2B5EF4-FFF2-40B4-BE49-F238E27FC236}">
                <a16:creationId xmlns:a16="http://schemas.microsoft.com/office/drawing/2014/main" id="{49447257-1002-C2D3-5D05-8F4740D53CE6}"/>
              </a:ext>
            </a:extLst>
          </p:cNvPr>
          <p:cNvSpPr txBox="1"/>
          <p:nvPr/>
        </p:nvSpPr>
        <p:spPr>
          <a:xfrm>
            <a:off x="2055019" y="4545330"/>
            <a:ext cx="808196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5. 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Effect of TGMP and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gS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upplemented with Polymyxin B (P) on bone marrow-derived dendritic cell activation markers MHCII and CD86 after 4 and 16 hours of stimulation.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ipopolysaccharide (LPS) was used as a positive control. Data are expressed as mean + SD (n = 3). MFI: Mean Fluorescence Intensity. Comparisons were made between stimulated cells and unstimulated cells (Ctr-) for each time point.</a:t>
            </a:r>
            <a:endParaRPr lang="pt-PT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62109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9</Words>
  <Application>Microsoft Office PowerPoint</Application>
  <PresentationFormat>Ecrã Panorâmico</PresentationFormat>
  <Paragraphs>1</Paragraphs>
  <Slides>1</Slides>
  <Notes>0</Notes>
  <HiddenSlides>0</HiddenSlides>
  <MMClips>0</MMClips>
  <ScaleCrop>false</ScaleCrop>
  <HeadingPairs>
    <vt:vector size="8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orporados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ema do Office</vt:lpstr>
      <vt:lpstr>Prism 8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ina Brito</dc:creator>
  <cp:lastModifiedBy>Margarida Borges</cp:lastModifiedBy>
  <cp:revision>8</cp:revision>
  <dcterms:created xsi:type="dcterms:W3CDTF">2026-05-22T17:54:58Z</dcterms:created>
  <dcterms:modified xsi:type="dcterms:W3CDTF">2026-06-16T09:01:31Z</dcterms:modified>
</cp:coreProperties>
</file>